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71" r:id="rId2"/>
    <p:sldId id="270" r:id="rId3"/>
    <p:sldId id="289" r:id="rId4"/>
    <p:sldId id="290" r:id="rId5"/>
  </p:sldIdLst>
  <p:sldSz cx="6858000" cy="9906000" type="A4"/>
  <p:notesSz cx="6783388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403" autoAdjust="0"/>
    <p:restoredTop sz="91654" autoAdjust="0"/>
  </p:normalViewPr>
  <p:slideViewPr>
    <p:cSldViewPr snapToGrid="0">
      <p:cViewPr varScale="1">
        <p:scale>
          <a:sx n="115" d="100"/>
          <a:sy n="115" d="100"/>
        </p:scale>
        <p:origin x="54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39468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2350" y="0"/>
            <a:ext cx="2939468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41D6DB0-9E42-40AE-943C-0D1BE95E13A5}" type="datetimeFigureOut">
              <a:rPr lang="en-US" smtClean="0"/>
              <a:t>7/10/2023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233613" y="1241425"/>
            <a:ext cx="2316162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8339" y="4777194"/>
            <a:ext cx="542671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39468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2350" y="9428584"/>
            <a:ext cx="2939468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0E462F6-C9F4-42F3-BDF9-6F83C550A56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85787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0E462F6-C9F4-42F3-BDF9-6F83C550A56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875858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0E462F6-C9F4-42F3-BDF9-6F83C550A56D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535650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0E462F6-C9F4-42F3-BDF9-6F83C550A56D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808438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0E462F6-C9F4-42F3-BDF9-6F83C550A56D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072965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FAC717-15C0-4078-B6D3-E828FF463861}" type="datetimeFigureOut">
              <a:rPr lang="de-DE" smtClean="0"/>
              <a:t>10.07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3F383-44DB-454B-A24C-5058C679B9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464367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FAC717-15C0-4078-B6D3-E828FF463861}" type="datetimeFigureOut">
              <a:rPr lang="de-DE" smtClean="0"/>
              <a:t>10.07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3F383-44DB-454B-A24C-5058C679B9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37261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FAC717-15C0-4078-B6D3-E828FF463861}" type="datetimeFigureOut">
              <a:rPr lang="de-DE" smtClean="0"/>
              <a:t>10.07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3F383-44DB-454B-A24C-5058C679B9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786548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FAC717-15C0-4078-B6D3-E828FF463861}" type="datetimeFigureOut">
              <a:rPr lang="de-DE" smtClean="0"/>
              <a:t>10.07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3F383-44DB-454B-A24C-5058C679B9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133992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FAC717-15C0-4078-B6D3-E828FF463861}" type="datetimeFigureOut">
              <a:rPr lang="de-DE" smtClean="0"/>
              <a:t>10.07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3F383-44DB-454B-A24C-5058C679B9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637595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FAC717-15C0-4078-B6D3-E828FF463861}" type="datetimeFigureOut">
              <a:rPr lang="de-DE" smtClean="0"/>
              <a:t>10.07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3F383-44DB-454B-A24C-5058C679B9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408522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FAC717-15C0-4078-B6D3-E828FF463861}" type="datetimeFigureOut">
              <a:rPr lang="de-DE" smtClean="0"/>
              <a:t>10.07.2023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3F383-44DB-454B-A24C-5058C679B9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520756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FAC717-15C0-4078-B6D3-E828FF463861}" type="datetimeFigureOut">
              <a:rPr lang="de-DE" smtClean="0"/>
              <a:t>10.07.2023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3F383-44DB-454B-A24C-5058C679B9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532550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FAC717-15C0-4078-B6D3-E828FF463861}" type="datetimeFigureOut">
              <a:rPr lang="de-DE" smtClean="0"/>
              <a:t>10.07.2023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3F383-44DB-454B-A24C-5058C679B9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832525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FAC717-15C0-4078-B6D3-E828FF463861}" type="datetimeFigureOut">
              <a:rPr lang="de-DE" smtClean="0"/>
              <a:t>10.07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3F383-44DB-454B-A24C-5058C679B9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911571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FAC717-15C0-4078-B6D3-E828FF463861}" type="datetimeFigureOut">
              <a:rPr lang="de-DE" smtClean="0"/>
              <a:t>10.07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3F383-44DB-454B-A24C-5058C679B9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542694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FAC717-15C0-4078-B6D3-E828FF463861}" type="datetimeFigureOut">
              <a:rPr lang="de-DE" smtClean="0"/>
              <a:t>10.07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73F383-44DB-454B-A24C-5058C679B9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903353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14" y="238576"/>
            <a:ext cx="6573012" cy="7217664"/>
          </a:xfrm>
          <a:prstGeom prst="rect">
            <a:avLst/>
          </a:prstGeom>
        </p:spPr>
      </p:pic>
      <p:sp>
        <p:nvSpPr>
          <p:cNvPr id="17" name="Textfeld 16"/>
          <p:cNvSpPr txBox="1"/>
          <p:nvPr/>
        </p:nvSpPr>
        <p:spPr>
          <a:xfrm>
            <a:off x="209801" y="7867819"/>
            <a:ext cx="6519273" cy="17851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: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Fitted Z-spectra of contrast-enhancing tumor tissue. The figure shows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tted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T Z-spectra and residuals of a representative voxel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of contrast-enhancing tumor tissue in a participant with larger depositions of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themoglobin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and hemosiderin in the tumor area (also depicted in Figure 2). The representative voxel is indicated by an asterisk (*) on contrast-enhanced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11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w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mages in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bfigure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uperimposed on the Z-spectra are the fit results of the sum of the contributors and each contributor individually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bfigures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)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how an exemplary fit for the 4-pool Lorentzian-fit model at a B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f 0.6 µT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nd 0.9 µT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he fitting was performed in the range of -250 to 250 ppm, but only the range of -25 to 25 ppm is shown for better visualization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bfigure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hows an exemplary fit for the 4-pool Lorentzian-fit and constant ssMT model with the added amine pool, which was fitted in the range of -6 to 6 ppm.</a:t>
            </a:r>
          </a:p>
        </p:txBody>
      </p:sp>
      <p:sp>
        <p:nvSpPr>
          <p:cNvPr id="4" name="Textfeld 3"/>
          <p:cNvSpPr txBox="1"/>
          <p:nvPr/>
        </p:nvSpPr>
        <p:spPr>
          <a:xfrm>
            <a:off x="89914" y="132735"/>
            <a:ext cx="389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3469437" y="132735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89914" y="3956045"/>
            <a:ext cx="389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3469437" y="3956045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611800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155" y="266008"/>
            <a:ext cx="6701028" cy="7313676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209801" y="7867819"/>
            <a:ext cx="6519273" cy="17851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: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Fitted Z-spectra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of tumor-associated T</a:t>
            </a:r>
            <a:r>
              <a:rPr lang="en-US" sz="11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w-FLAIR-hyperintense signal alterations. The figure shows fitted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T Z-spectra and residuals of a representative voxel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eritumoral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T</a:t>
            </a:r>
            <a:r>
              <a:rPr lang="en-US" sz="11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w-FLAIR-hyperintense signal alterations in a participant with larger depositions of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themoglobin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and hemosiderin in the tumor area (also depicted in Figure 2). The representative voxel is indicated by an asterisk (*) on T</a:t>
            </a:r>
            <a:r>
              <a:rPr lang="en-US" sz="11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w-FLAIR images in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bfigure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uperimposed on the Z-spectra are the fit results of the sum of the contributors and each contributor individually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bfigures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)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how an exemplary fit for the 4-pool Lorentzian-fit model at a B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f 0.6 µT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nd 0.9 µT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he fitting was performed in the range of -250 to 250 ppm, but only the range of -25 to 25 ppm is shown for better visualization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bfigure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hows an exemplary fit for the 4-pool Lorentzian-fit and constant ssMT model with the added amine pool, which was fitted in the range of -6 to 6 ppm.</a:t>
            </a:r>
          </a:p>
        </p:txBody>
      </p:sp>
      <p:sp>
        <p:nvSpPr>
          <p:cNvPr id="6" name="Textfeld 5"/>
          <p:cNvSpPr txBox="1"/>
          <p:nvPr/>
        </p:nvSpPr>
        <p:spPr>
          <a:xfrm>
            <a:off x="62155" y="262291"/>
            <a:ext cx="389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3268100" y="262291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62155" y="3882342"/>
            <a:ext cx="389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3268100" y="3882342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965683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5841" y="220218"/>
            <a:ext cx="6550152" cy="7149084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209801" y="7867819"/>
            <a:ext cx="6519273" cy="17851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: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Fitted Z-spectra of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umor-associated hemosiderin. The figure shows fitted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T Z-spectra and residuals of a representative voxel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of hemosiderin (Hs), which is associated with a signal loss on susceptibility-weighted imaging (SWI), in a participant with larger depositions of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themoglobin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and Hs in the tumor area (also depicted in Figure 2). The representative voxel is indicated by an asterisk (*) on SWI in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bfigure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uperimposed on the Z-spectra are the fit results of the sum of the contributors and each contributor individually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bfigures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)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how an exemplary fit for the 4-pool Lorentzian-fit model at a B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f 0.6 µT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nd 0.9 µT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he fitting was performed in the range of -250 to 250 ppm, but only the range of -25 to 25 ppm is shown for better visualization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bfigure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hows an exemplary fit for the 4-pool Lorentzian-fit and constant ssMT model with the added amine pool, which was fitted in the range of -6 to 6 ppm.</a:t>
            </a:r>
          </a:p>
        </p:txBody>
      </p:sp>
      <p:sp>
        <p:nvSpPr>
          <p:cNvPr id="6" name="Textfeld 5"/>
          <p:cNvSpPr txBox="1"/>
          <p:nvPr/>
        </p:nvSpPr>
        <p:spPr>
          <a:xfrm>
            <a:off x="89914" y="132735"/>
            <a:ext cx="389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3469437" y="132735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89914" y="3956045"/>
            <a:ext cx="389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3469437" y="3956045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964037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9801" y="317401"/>
            <a:ext cx="6478524" cy="7069836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209801" y="7867819"/>
            <a:ext cx="6519273" cy="1615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4: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Fitted Z-spectra of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umor-associated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themoglobin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itted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T Z-spectra and residuals of a representative voxel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of T</a:t>
            </a:r>
            <a:r>
              <a:rPr lang="en-US" sz="11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w-hyperintense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themoglobin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Hb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n a participant with larger depositions of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Hb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and hemosiderin in the tumor area (also depicted in Figure 2). The representative voxel is indicated by an asterisk (*) on T</a:t>
            </a:r>
            <a:r>
              <a:rPr lang="en-US" sz="11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w images in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bfigure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uperimposed on the Z-spectra are the fit results of the sum of the contributors and each contributor individually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bfigures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)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how an exemplary fit for the 4-pool Lorentzian-fit model at a B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f 0.6 µT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nd 0.9 µT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he fitting was performed in the range of -250 to 250 ppm, but only the range of -25 to 25 ppm is shown for better visualization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bfigure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)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hows an exemplary fit for the 4-pool Lorentzian-fit and constant ssMT model with the added amine pool, which was fitted in the range of -6 to 6 ppm.</a:t>
            </a:r>
          </a:p>
        </p:txBody>
      </p:sp>
      <p:sp>
        <p:nvSpPr>
          <p:cNvPr id="6" name="Textfeld 5"/>
          <p:cNvSpPr txBox="1"/>
          <p:nvPr/>
        </p:nvSpPr>
        <p:spPr>
          <a:xfrm>
            <a:off x="89914" y="317132"/>
            <a:ext cx="389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3469437" y="317132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89914" y="3956045"/>
            <a:ext cx="389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3469437" y="3956045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911480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53</Words>
  <Application>Microsoft Office PowerPoint</Application>
  <PresentationFormat>A4-Papier (210 x 297 mm)</PresentationFormat>
  <Paragraphs>24</Paragraphs>
  <Slides>4</Slides>
  <Notes>4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-Präsentation</vt:lpstr>
      <vt:lpstr>PowerPoint-Präsentation</vt:lpstr>
      <vt:lpstr>PowerPoint-Präsentation</vt:lpstr>
      <vt:lpstr>PowerPoint-Präsentation</vt:lpstr>
    </vt:vector>
  </TitlesOfParts>
  <Company>DKFZ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von Knebel Doeberitz, Nikolaus</dc:creator>
  <cp:lastModifiedBy>von Knebel Doeberitz, Nikolaus</cp:lastModifiedBy>
  <cp:revision>357</cp:revision>
  <cp:lastPrinted>2023-06-22T12:21:33Z</cp:lastPrinted>
  <dcterms:created xsi:type="dcterms:W3CDTF">2022-10-17T12:56:36Z</dcterms:created>
  <dcterms:modified xsi:type="dcterms:W3CDTF">2023-07-12T09:25:18Z</dcterms:modified>
</cp:coreProperties>
</file>